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11" r:id="rId2"/>
    <p:sldId id="318" r:id="rId3"/>
    <p:sldId id="319" r:id="rId4"/>
    <p:sldId id="315" r:id="rId5"/>
    <p:sldId id="300" r:id="rId6"/>
    <p:sldId id="316" r:id="rId7"/>
    <p:sldId id="314" r:id="rId8"/>
    <p:sldId id="306" r:id="rId9"/>
  </p:sldIdLst>
  <p:sldSz cx="7442200" cy="9740900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68" userDrawn="1">
          <p15:clr>
            <a:srgbClr val="A4A3A4"/>
          </p15:clr>
        </p15:guide>
        <p15:guide id="2" pos="23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8A66DEA-14D3-498F-AE15-2DBB5E3A13C5}" v="13" dt="2023-09-29T18:48:53.1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84005" autoAdjust="0"/>
  </p:normalViewPr>
  <p:slideViewPr>
    <p:cSldViewPr>
      <p:cViewPr varScale="1">
        <p:scale>
          <a:sx n="72" d="100"/>
          <a:sy n="72" d="100"/>
        </p:scale>
        <p:origin x="462" y="78"/>
      </p:cViewPr>
      <p:guideLst>
        <p:guide orient="horz" pos="3068"/>
        <p:guide pos="234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umar, Vinod" userId="a0710a6e-bffc-4971-8893-1c23addeb5b0" providerId="ADAL" clId="{58A66DEA-14D3-498F-AE15-2DBB5E3A13C5}"/>
    <pc:docChg chg="undo custSel addSld delSld modSld sldOrd">
      <pc:chgData name="Kumar, Vinod" userId="a0710a6e-bffc-4971-8893-1c23addeb5b0" providerId="ADAL" clId="{58A66DEA-14D3-498F-AE15-2DBB5E3A13C5}" dt="2023-09-29T18:49:37.527" v="338" actId="1038"/>
      <pc:docMkLst>
        <pc:docMk/>
      </pc:docMkLst>
      <pc:sldChg chg="modSp mod">
        <pc:chgData name="Kumar, Vinod" userId="a0710a6e-bffc-4971-8893-1c23addeb5b0" providerId="ADAL" clId="{58A66DEA-14D3-498F-AE15-2DBB5E3A13C5}" dt="2023-09-26T19:06:38.087" v="103" actId="20577"/>
        <pc:sldMkLst>
          <pc:docMk/>
          <pc:sldMk cId="2313405284" sldId="300"/>
        </pc:sldMkLst>
        <pc:spChg chg="mod">
          <ac:chgData name="Kumar, Vinod" userId="a0710a6e-bffc-4971-8893-1c23addeb5b0" providerId="ADAL" clId="{58A66DEA-14D3-498F-AE15-2DBB5E3A13C5}" dt="2023-09-26T19:06:38.087" v="103" actId="20577"/>
          <ac:spMkLst>
            <pc:docMk/>
            <pc:sldMk cId="2313405284" sldId="300"/>
            <ac:spMk id="2" creationId="{E836C5DC-7746-C954-BC1F-3B9F0DA30868}"/>
          </ac:spMkLst>
        </pc:spChg>
      </pc:sldChg>
      <pc:sldChg chg="modSp mod">
        <pc:chgData name="Kumar, Vinod" userId="a0710a6e-bffc-4971-8893-1c23addeb5b0" providerId="ADAL" clId="{58A66DEA-14D3-498F-AE15-2DBB5E3A13C5}" dt="2023-09-14T15:11:16.180" v="81" actId="20577"/>
        <pc:sldMkLst>
          <pc:docMk/>
          <pc:sldMk cId="1231753045" sldId="306"/>
        </pc:sldMkLst>
        <pc:spChg chg="mod">
          <ac:chgData name="Kumar, Vinod" userId="a0710a6e-bffc-4971-8893-1c23addeb5b0" providerId="ADAL" clId="{58A66DEA-14D3-498F-AE15-2DBB5E3A13C5}" dt="2023-09-14T15:11:16.180" v="81" actId="20577"/>
          <ac:spMkLst>
            <pc:docMk/>
            <pc:sldMk cId="1231753045" sldId="306"/>
            <ac:spMk id="7" creationId="{C56CA07C-310B-7CB3-A9A5-D9A9ED7A54FF}"/>
          </ac:spMkLst>
        </pc:spChg>
      </pc:sldChg>
      <pc:sldChg chg="addSp delSp modSp mod ord">
        <pc:chgData name="Kumar, Vinod" userId="a0710a6e-bffc-4971-8893-1c23addeb5b0" providerId="ADAL" clId="{58A66DEA-14D3-498F-AE15-2DBB5E3A13C5}" dt="2023-09-29T18:49:37.527" v="338" actId="1038"/>
        <pc:sldMkLst>
          <pc:docMk/>
          <pc:sldMk cId="1021580243" sldId="311"/>
        </pc:sldMkLst>
        <pc:spChg chg="add mod">
          <ac:chgData name="Kumar, Vinod" userId="a0710a6e-bffc-4971-8893-1c23addeb5b0" providerId="ADAL" clId="{58A66DEA-14D3-498F-AE15-2DBB5E3A13C5}" dt="2023-09-26T19:04:40.712" v="100" actId="20577"/>
          <ac:spMkLst>
            <pc:docMk/>
            <pc:sldMk cId="1021580243" sldId="311"/>
            <ac:spMk id="2" creationId="{6083932F-2E5E-DB08-C4E7-D4761E2D546E}"/>
          </ac:spMkLst>
        </pc:spChg>
        <pc:spChg chg="mod topLvl">
          <ac:chgData name="Kumar, Vinod" userId="a0710a6e-bffc-4971-8893-1c23addeb5b0" providerId="ADAL" clId="{58A66DEA-14D3-498F-AE15-2DBB5E3A13C5}" dt="2023-09-25T17:40:22.323" v="87" actId="165"/>
          <ac:spMkLst>
            <pc:docMk/>
            <pc:sldMk cId="1021580243" sldId="311"/>
            <ac:spMk id="5" creationId="{0706E1CA-626E-467D-593C-0057BB6A2FEA}"/>
          </ac:spMkLst>
        </pc:spChg>
        <pc:spChg chg="add mod">
          <ac:chgData name="Kumar, Vinod" userId="a0710a6e-bffc-4971-8893-1c23addeb5b0" providerId="ADAL" clId="{58A66DEA-14D3-498F-AE15-2DBB5E3A13C5}" dt="2023-09-29T17:45:33.779" v="244" actId="1035"/>
          <ac:spMkLst>
            <pc:docMk/>
            <pc:sldMk cId="1021580243" sldId="311"/>
            <ac:spMk id="6" creationId="{CB35D54D-7458-A0A2-9FC5-B682EBE4E347}"/>
          </ac:spMkLst>
        </pc:spChg>
        <pc:spChg chg="add mod">
          <ac:chgData name="Kumar, Vinod" userId="a0710a6e-bffc-4971-8893-1c23addeb5b0" providerId="ADAL" clId="{58A66DEA-14D3-498F-AE15-2DBB5E3A13C5}" dt="2023-09-29T17:45:43.650" v="265" actId="1037"/>
          <ac:spMkLst>
            <pc:docMk/>
            <pc:sldMk cId="1021580243" sldId="311"/>
            <ac:spMk id="7" creationId="{599B3237-0596-971D-DBCF-FD37883C1CA8}"/>
          </ac:spMkLst>
        </pc:spChg>
        <pc:spChg chg="mod topLvl">
          <ac:chgData name="Kumar, Vinod" userId="a0710a6e-bffc-4971-8893-1c23addeb5b0" providerId="ADAL" clId="{58A66DEA-14D3-498F-AE15-2DBB5E3A13C5}" dt="2023-09-26T19:03:34.367" v="94" actId="1076"/>
          <ac:spMkLst>
            <pc:docMk/>
            <pc:sldMk cId="1021580243" sldId="311"/>
            <ac:spMk id="44" creationId="{11B92327-31CB-614A-D505-DE770E18F202}"/>
          </ac:spMkLst>
        </pc:spChg>
        <pc:spChg chg="mod topLvl">
          <ac:chgData name="Kumar, Vinod" userId="a0710a6e-bffc-4971-8893-1c23addeb5b0" providerId="ADAL" clId="{58A66DEA-14D3-498F-AE15-2DBB5E3A13C5}" dt="2023-09-26T19:03:34.367" v="94" actId="1076"/>
          <ac:spMkLst>
            <pc:docMk/>
            <pc:sldMk cId="1021580243" sldId="311"/>
            <ac:spMk id="45" creationId="{026710EE-A656-3547-974F-F1654F7242CD}"/>
          </ac:spMkLst>
        </pc:spChg>
        <pc:grpChg chg="del mod">
          <ac:chgData name="Kumar, Vinod" userId="a0710a6e-bffc-4971-8893-1c23addeb5b0" providerId="ADAL" clId="{58A66DEA-14D3-498F-AE15-2DBB5E3A13C5}" dt="2023-09-25T17:40:22.323" v="87" actId="165"/>
          <ac:grpSpMkLst>
            <pc:docMk/>
            <pc:sldMk cId="1021580243" sldId="311"/>
            <ac:grpSpMk id="2" creationId="{F908F5F5-01FE-2345-FA23-2C5760D858C6}"/>
          </ac:grpSpMkLst>
        </pc:grpChg>
        <pc:picChg chg="add mod">
          <ac:chgData name="Kumar, Vinod" userId="a0710a6e-bffc-4971-8893-1c23addeb5b0" providerId="ADAL" clId="{58A66DEA-14D3-498F-AE15-2DBB5E3A13C5}" dt="2023-09-26T19:04:33.407" v="99" actId="1076"/>
          <ac:picMkLst>
            <pc:docMk/>
            <pc:sldMk cId="1021580243" sldId="311"/>
            <ac:picMk id="3" creationId="{828EB3CC-7B85-6A56-30B5-CEDC5FB3179D}"/>
          </ac:picMkLst>
        </pc:picChg>
        <pc:picChg chg="add del mod modCrop">
          <ac:chgData name="Kumar, Vinod" userId="a0710a6e-bffc-4971-8893-1c23addeb5b0" providerId="ADAL" clId="{58A66DEA-14D3-498F-AE15-2DBB5E3A13C5}" dt="2023-09-29T18:49:19.942" v="279" actId="478"/>
          <ac:picMkLst>
            <pc:docMk/>
            <pc:sldMk cId="1021580243" sldId="311"/>
            <ac:picMk id="4" creationId="{CE10F9F1-BF58-E594-A9FD-ED8FEED1EFA9}"/>
          </ac:picMkLst>
        </pc:picChg>
        <pc:picChg chg="del mod">
          <ac:chgData name="Kumar, Vinod" userId="a0710a6e-bffc-4971-8893-1c23addeb5b0" providerId="ADAL" clId="{58A66DEA-14D3-498F-AE15-2DBB5E3A13C5}" dt="2023-09-29T18:48:34.951" v="270"/>
          <ac:picMkLst>
            <pc:docMk/>
            <pc:sldMk cId="1021580243" sldId="311"/>
            <ac:picMk id="8" creationId="{0D7D99A5-469B-5495-ABA9-C4A68ED81717}"/>
          </ac:picMkLst>
        </pc:picChg>
        <pc:picChg chg="add del">
          <ac:chgData name="Kumar, Vinod" userId="a0710a6e-bffc-4971-8893-1c23addeb5b0" providerId="ADAL" clId="{58A66DEA-14D3-498F-AE15-2DBB5E3A13C5}" dt="2023-09-29T18:48:34.416" v="269"/>
          <ac:picMkLst>
            <pc:docMk/>
            <pc:sldMk cId="1021580243" sldId="311"/>
            <ac:picMk id="9" creationId="{6B538923-6273-BDCF-B1BD-5AD08F431447}"/>
          </ac:picMkLst>
        </pc:picChg>
        <pc:picChg chg="add del mod">
          <ac:chgData name="Kumar, Vinod" userId="a0710a6e-bffc-4971-8893-1c23addeb5b0" providerId="ADAL" clId="{58A66DEA-14D3-498F-AE15-2DBB5E3A13C5}" dt="2023-09-29T18:48:44.711" v="273" actId="478"/>
          <ac:picMkLst>
            <pc:docMk/>
            <pc:sldMk cId="1021580243" sldId="311"/>
            <ac:picMk id="10" creationId="{C09F56E0-D8FD-4585-CEB9-2A8B0017146D}"/>
          </ac:picMkLst>
        </pc:picChg>
        <pc:picChg chg="mod modCrop">
          <ac:chgData name="Kumar, Vinod" userId="a0710a6e-bffc-4971-8893-1c23addeb5b0" providerId="ADAL" clId="{58A66DEA-14D3-498F-AE15-2DBB5E3A13C5}" dt="2023-09-29T18:49:37.527" v="338" actId="1038"/>
          <ac:picMkLst>
            <pc:docMk/>
            <pc:sldMk cId="1021580243" sldId="311"/>
            <ac:picMk id="11" creationId="{F6F4EFAB-2AD0-9F49-4A31-AFF7453C4987}"/>
          </ac:picMkLst>
        </pc:picChg>
        <pc:picChg chg="mod topLvl">
          <ac:chgData name="Kumar, Vinod" userId="a0710a6e-bffc-4971-8893-1c23addeb5b0" providerId="ADAL" clId="{58A66DEA-14D3-498F-AE15-2DBB5E3A13C5}" dt="2023-09-26T19:03:34.367" v="94" actId="1076"/>
          <ac:picMkLst>
            <pc:docMk/>
            <pc:sldMk cId="1021580243" sldId="311"/>
            <ac:picMk id="12" creationId="{482CDF10-2FE6-493B-D78B-BDA2C5FCB7C0}"/>
          </ac:picMkLst>
        </pc:picChg>
        <pc:picChg chg="mod topLvl">
          <ac:chgData name="Kumar, Vinod" userId="a0710a6e-bffc-4971-8893-1c23addeb5b0" providerId="ADAL" clId="{58A66DEA-14D3-498F-AE15-2DBB5E3A13C5}" dt="2023-09-26T19:03:34.367" v="94" actId="1076"/>
          <ac:picMkLst>
            <pc:docMk/>
            <pc:sldMk cId="1021580243" sldId="311"/>
            <ac:picMk id="13" creationId="{DE3E22C3-029E-611F-7B63-DEAD49EBF0E0}"/>
          </ac:picMkLst>
        </pc:picChg>
      </pc:sldChg>
      <pc:sldChg chg="modSp mod">
        <pc:chgData name="Kumar, Vinod" userId="a0710a6e-bffc-4971-8893-1c23addeb5b0" providerId="ADAL" clId="{58A66DEA-14D3-498F-AE15-2DBB5E3A13C5}" dt="2023-09-26T19:07:01.255" v="104" actId="20577"/>
        <pc:sldMkLst>
          <pc:docMk/>
          <pc:sldMk cId="2551874591" sldId="314"/>
        </pc:sldMkLst>
        <pc:spChg chg="mod">
          <ac:chgData name="Kumar, Vinod" userId="a0710a6e-bffc-4971-8893-1c23addeb5b0" providerId="ADAL" clId="{58A66DEA-14D3-498F-AE15-2DBB5E3A13C5}" dt="2023-09-26T19:07:01.255" v="104" actId="20577"/>
          <ac:spMkLst>
            <pc:docMk/>
            <pc:sldMk cId="2551874591" sldId="314"/>
            <ac:spMk id="2" creationId="{73A89AD1-9494-8A53-6332-6DA335F33ECF}"/>
          </ac:spMkLst>
        </pc:spChg>
      </pc:sldChg>
      <pc:sldChg chg="delSp modSp mod">
        <pc:chgData name="Kumar, Vinod" userId="a0710a6e-bffc-4971-8893-1c23addeb5b0" providerId="ADAL" clId="{58A66DEA-14D3-498F-AE15-2DBB5E3A13C5}" dt="2023-09-26T19:05:51.406" v="102" actId="1076"/>
        <pc:sldMkLst>
          <pc:docMk/>
          <pc:sldMk cId="87050650" sldId="315"/>
        </pc:sldMkLst>
        <pc:spChg chg="mod">
          <ac:chgData name="Kumar, Vinod" userId="a0710a6e-bffc-4971-8893-1c23addeb5b0" providerId="ADAL" clId="{58A66DEA-14D3-498F-AE15-2DBB5E3A13C5}" dt="2023-09-26T19:05:51.406" v="102" actId="1076"/>
          <ac:spMkLst>
            <pc:docMk/>
            <pc:sldMk cId="87050650" sldId="315"/>
            <ac:spMk id="2" creationId="{DFB14EE7-EEF6-61F7-41BC-5E90AAE62A50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3" creationId="{549D2B20-EC28-516E-1781-12FB854F9CC7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4" creationId="{34897CEC-8788-4E23-A2EB-129E341C1E2C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5" creationId="{EBE000ED-B1A1-3050-3231-53F952EF004E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6" creationId="{D598E17B-EB7B-D68E-071E-EAF0ECE784BD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7" creationId="{B6E398F8-4570-6114-9D17-E136BFDC1614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8" creationId="{8B182684-1A9D-EEA6-5871-DD72E987E31A}"/>
          </ac:spMkLst>
        </pc:spChg>
        <pc:spChg chg="del">
          <ac:chgData name="Kumar, Vinod" userId="a0710a6e-bffc-4971-8893-1c23addeb5b0" providerId="ADAL" clId="{58A66DEA-14D3-498F-AE15-2DBB5E3A13C5}" dt="2023-09-14T15:01:03.817" v="1" actId="478"/>
          <ac:spMkLst>
            <pc:docMk/>
            <pc:sldMk cId="87050650" sldId="315"/>
            <ac:spMk id="9" creationId="{B5482599-9DD0-C32C-1446-5E037C93065E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10" creationId="{F88FF6F7-3F90-A2CD-FEF6-B15AC9DE672B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18" creationId="{6BDF7E7D-EC93-091B-3714-48C043BEAA7B}"/>
          </ac:spMkLst>
        </pc:spChg>
        <pc:spChg chg="del">
          <ac:chgData name="Kumar, Vinod" userId="a0710a6e-bffc-4971-8893-1c23addeb5b0" providerId="ADAL" clId="{58A66DEA-14D3-498F-AE15-2DBB5E3A13C5}" dt="2023-09-14T15:01:21.113" v="63" actId="478"/>
          <ac:spMkLst>
            <pc:docMk/>
            <pc:sldMk cId="87050650" sldId="315"/>
            <ac:spMk id="21" creationId="{D7D88FA0-6D0C-96BF-6837-CE8C7D2C18F7}"/>
          </ac:spMkLst>
        </pc:spChg>
        <pc:spChg chg="mod">
          <ac:chgData name="Kumar, Vinod" userId="a0710a6e-bffc-4971-8893-1c23addeb5b0" providerId="ADAL" clId="{58A66DEA-14D3-498F-AE15-2DBB5E3A13C5}" dt="2023-09-14T15:01:27.914" v="64" actId="20577"/>
          <ac:spMkLst>
            <pc:docMk/>
            <pc:sldMk cId="87050650" sldId="315"/>
            <ac:spMk id="22" creationId="{56DBA533-46D5-F4DE-11B3-F9F694AA03DD}"/>
          </ac:spMkLst>
        </pc:spChg>
        <pc:spChg chg="del">
          <ac:chgData name="Kumar, Vinod" userId="a0710a6e-bffc-4971-8893-1c23addeb5b0" providerId="ADAL" clId="{58A66DEA-14D3-498F-AE15-2DBB5E3A13C5}" dt="2023-09-14T15:01:00.714" v="0" actId="478"/>
          <ac:spMkLst>
            <pc:docMk/>
            <pc:sldMk cId="87050650" sldId="315"/>
            <ac:spMk id="26" creationId="{3FC68601-31B8-0469-A675-57F85B2832D4}"/>
          </ac:spMkLst>
        </pc:spChg>
        <pc:picChg chg="del">
          <ac:chgData name="Kumar, Vinod" userId="a0710a6e-bffc-4971-8893-1c23addeb5b0" providerId="ADAL" clId="{58A66DEA-14D3-498F-AE15-2DBB5E3A13C5}" dt="2023-09-14T15:01:00.714" v="0" actId="478"/>
          <ac:picMkLst>
            <pc:docMk/>
            <pc:sldMk cId="87050650" sldId="315"/>
            <ac:picMk id="11" creationId="{548D93EB-C38F-65EF-4A59-4F410E66F21E}"/>
          </ac:picMkLst>
        </pc:picChg>
        <pc:picChg chg="del">
          <ac:chgData name="Kumar, Vinod" userId="a0710a6e-bffc-4971-8893-1c23addeb5b0" providerId="ADAL" clId="{58A66DEA-14D3-498F-AE15-2DBB5E3A13C5}" dt="2023-09-14T15:01:00.714" v="0" actId="478"/>
          <ac:picMkLst>
            <pc:docMk/>
            <pc:sldMk cId="87050650" sldId="315"/>
            <ac:picMk id="12" creationId="{BCF04BB9-FA09-3864-9A77-BBDBC91583A6}"/>
          </ac:picMkLst>
        </pc:picChg>
        <pc:picChg chg="del">
          <ac:chgData name="Kumar, Vinod" userId="a0710a6e-bffc-4971-8893-1c23addeb5b0" providerId="ADAL" clId="{58A66DEA-14D3-498F-AE15-2DBB5E3A13C5}" dt="2023-09-14T15:01:00.714" v="0" actId="478"/>
          <ac:picMkLst>
            <pc:docMk/>
            <pc:sldMk cId="87050650" sldId="315"/>
            <ac:picMk id="17" creationId="{212EC4EF-77B3-5368-6E6B-A75EF87935BA}"/>
          </ac:picMkLst>
        </pc:picChg>
        <pc:picChg chg="mod">
          <ac:chgData name="Kumar, Vinod" userId="a0710a6e-bffc-4971-8893-1c23addeb5b0" providerId="ADAL" clId="{58A66DEA-14D3-498F-AE15-2DBB5E3A13C5}" dt="2023-09-14T15:01:17.320" v="62" actId="1038"/>
          <ac:picMkLst>
            <pc:docMk/>
            <pc:sldMk cId="87050650" sldId="315"/>
            <ac:picMk id="19" creationId="{F42524B6-CD05-7E8E-53B3-CF6EDDB555D5}"/>
          </ac:picMkLst>
        </pc:picChg>
        <pc:cxnChg chg="del">
          <ac:chgData name="Kumar, Vinod" userId="a0710a6e-bffc-4971-8893-1c23addeb5b0" providerId="ADAL" clId="{58A66DEA-14D3-498F-AE15-2DBB5E3A13C5}" dt="2023-09-14T15:01:00.714" v="0" actId="478"/>
          <ac:cxnSpMkLst>
            <pc:docMk/>
            <pc:sldMk cId="87050650" sldId="315"/>
            <ac:cxnSpMk id="13" creationId="{7A471A29-F0CC-D035-4611-68861ABA1583}"/>
          </ac:cxnSpMkLst>
        </pc:cxnChg>
        <pc:cxnChg chg="del">
          <ac:chgData name="Kumar, Vinod" userId="a0710a6e-bffc-4971-8893-1c23addeb5b0" providerId="ADAL" clId="{58A66DEA-14D3-498F-AE15-2DBB5E3A13C5}" dt="2023-09-14T15:01:00.714" v="0" actId="478"/>
          <ac:cxnSpMkLst>
            <pc:docMk/>
            <pc:sldMk cId="87050650" sldId="315"/>
            <ac:cxnSpMk id="14" creationId="{F72EE062-61B2-5D71-EE1F-16D26BC6BF5A}"/>
          </ac:cxnSpMkLst>
        </pc:cxnChg>
      </pc:sldChg>
      <pc:sldChg chg="delSp mod">
        <pc:chgData name="Kumar, Vinod" userId="a0710a6e-bffc-4971-8893-1c23addeb5b0" providerId="ADAL" clId="{58A66DEA-14D3-498F-AE15-2DBB5E3A13C5}" dt="2023-09-15T15:12:17.235" v="82" actId="478"/>
        <pc:sldMkLst>
          <pc:docMk/>
          <pc:sldMk cId="1532816129" sldId="316"/>
        </pc:sldMkLst>
        <pc:spChg chg="del">
          <ac:chgData name="Kumar, Vinod" userId="a0710a6e-bffc-4971-8893-1c23addeb5b0" providerId="ADAL" clId="{58A66DEA-14D3-498F-AE15-2DBB5E3A13C5}" dt="2023-09-15T15:12:17.235" v="82" actId="478"/>
          <ac:spMkLst>
            <pc:docMk/>
            <pc:sldMk cId="1532816129" sldId="316"/>
            <ac:spMk id="5" creationId="{94D09A20-EEED-EF31-E9D5-8EDBEECF2980}"/>
          </ac:spMkLst>
        </pc:spChg>
        <pc:spChg chg="del">
          <ac:chgData name="Kumar, Vinod" userId="a0710a6e-bffc-4971-8893-1c23addeb5b0" providerId="ADAL" clId="{58A66DEA-14D3-498F-AE15-2DBB5E3A13C5}" dt="2023-09-15T15:12:17.235" v="82" actId="478"/>
          <ac:spMkLst>
            <pc:docMk/>
            <pc:sldMk cId="1532816129" sldId="316"/>
            <ac:spMk id="8" creationId="{9850584D-BFDC-9D28-3109-2D3DB24FD68A}"/>
          </ac:spMkLst>
        </pc:spChg>
        <pc:picChg chg="del">
          <ac:chgData name="Kumar, Vinod" userId="a0710a6e-bffc-4971-8893-1c23addeb5b0" providerId="ADAL" clId="{58A66DEA-14D3-498F-AE15-2DBB5E3A13C5}" dt="2023-09-15T15:12:17.235" v="82" actId="478"/>
          <ac:picMkLst>
            <pc:docMk/>
            <pc:sldMk cId="1532816129" sldId="316"/>
            <ac:picMk id="6" creationId="{058DE827-E10E-5A95-735D-29BB2722B6D6}"/>
          </ac:picMkLst>
        </pc:picChg>
        <pc:picChg chg="del">
          <ac:chgData name="Kumar, Vinod" userId="a0710a6e-bffc-4971-8893-1c23addeb5b0" providerId="ADAL" clId="{58A66DEA-14D3-498F-AE15-2DBB5E3A13C5}" dt="2023-09-15T15:12:17.235" v="82" actId="478"/>
          <ac:picMkLst>
            <pc:docMk/>
            <pc:sldMk cId="1532816129" sldId="316"/>
            <ac:picMk id="7" creationId="{D82FA61F-C795-637F-6F85-B9B730E85D64}"/>
          </ac:picMkLst>
        </pc:picChg>
      </pc:sldChg>
      <pc:sldChg chg="addSp modSp new del mod">
        <pc:chgData name="Kumar, Vinod" userId="a0710a6e-bffc-4971-8893-1c23addeb5b0" providerId="ADAL" clId="{58A66DEA-14D3-498F-AE15-2DBB5E3A13C5}" dt="2023-09-26T19:07:50.151" v="105" actId="47"/>
        <pc:sldMkLst>
          <pc:docMk/>
          <pc:sldMk cId="1313300200" sldId="317"/>
        </pc:sldMkLst>
        <pc:spChg chg="add mod">
          <ac:chgData name="Kumar, Vinod" userId="a0710a6e-bffc-4971-8893-1c23addeb5b0" providerId="ADAL" clId="{58A66DEA-14D3-498F-AE15-2DBB5E3A13C5}" dt="2023-09-14T15:11:08.885" v="80" actId="20577"/>
          <ac:spMkLst>
            <pc:docMk/>
            <pc:sldMk cId="1313300200" sldId="317"/>
            <ac:spMk id="3" creationId="{0C9C547F-5B9F-534F-8948-367A964477AA}"/>
          </ac:spMkLst>
        </pc:spChg>
        <pc:picChg chg="add mod modCrop">
          <ac:chgData name="Kumar, Vinod" userId="a0710a6e-bffc-4971-8893-1c23addeb5b0" providerId="ADAL" clId="{58A66DEA-14D3-498F-AE15-2DBB5E3A13C5}" dt="2023-09-14T15:10:30.837" v="78" actId="1076"/>
          <ac:picMkLst>
            <pc:docMk/>
            <pc:sldMk cId="1313300200" sldId="317"/>
            <ac:picMk id="2" creationId="{99EF3041-480A-4D5A-91EA-D4CB8EDE825B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145967-F332-4C76-936E-591AC2206752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5525" y="1160463"/>
            <a:ext cx="2393950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225"/>
            <a:ext cx="5588000" cy="3656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3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0" y="8818563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EB94F1-CF9C-4D63-BFA2-8C28093D8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678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58165" y="3025996"/>
            <a:ext cx="6325870" cy="208798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16331" y="5519845"/>
            <a:ext cx="5209540" cy="24893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599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198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797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396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995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594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193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792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332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108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5595" y="390094"/>
            <a:ext cx="1674495" cy="83113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2110" y="390094"/>
            <a:ext cx="4899448" cy="83113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517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45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7883" y="6259433"/>
            <a:ext cx="6325870" cy="1934651"/>
          </a:xfrm>
        </p:spPr>
        <p:txBody>
          <a:bodyPr anchor="t"/>
          <a:lstStyle>
            <a:lvl1pPr algn="l">
              <a:defRPr sz="577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7883" y="4128616"/>
            <a:ext cx="6325870" cy="2130821"/>
          </a:xfrm>
        </p:spPr>
        <p:txBody>
          <a:bodyPr anchor="b"/>
          <a:lstStyle>
            <a:lvl1pPr marL="0" indent="0">
              <a:buNone/>
              <a:defRPr sz="2887">
                <a:solidFill>
                  <a:schemeClr val="tx1">
                    <a:tint val="75000"/>
                  </a:schemeClr>
                </a:solidFill>
              </a:defRPr>
            </a:lvl1pPr>
            <a:lvl2pPr marL="659903" indent="0">
              <a:buNone/>
              <a:defRPr sz="2598">
                <a:solidFill>
                  <a:schemeClr val="tx1">
                    <a:tint val="75000"/>
                  </a:schemeClr>
                </a:solidFill>
              </a:defRPr>
            </a:lvl2pPr>
            <a:lvl3pPr marL="1319806" indent="0">
              <a:buNone/>
              <a:defRPr sz="2309">
                <a:solidFill>
                  <a:schemeClr val="tx1">
                    <a:tint val="75000"/>
                  </a:schemeClr>
                </a:solidFill>
              </a:defRPr>
            </a:lvl3pPr>
            <a:lvl4pPr marL="1979708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4pPr>
            <a:lvl5pPr marL="2639611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5pPr>
            <a:lvl6pPr marL="3299516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6pPr>
            <a:lvl7pPr marL="3959416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7pPr>
            <a:lvl8pPr marL="4619318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8pPr>
            <a:lvl9pPr marL="5279223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61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2110" y="2272883"/>
            <a:ext cx="3286972" cy="6428542"/>
          </a:xfrm>
        </p:spPr>
        <p:txBody>
          <a:bodyPr/>
          <a:lstStyle>
            <a:lvl1pPr>
              <a:defRPr sz="4041"/>
            </a:lvl1pPr>
            <a:lvl2pPr>
              <a:defRPr sz="3464"/>
            </a:lvl2pPr>
            <a:lvl3pPr>
              <a:defRPr sz="2887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3118" y="2272883"/>
            <a:ext cx="3286972" cy="6428542"/>
          </a:xfrm>
        </p:spPr>
        <p:txBody>
          <a:bodyPr/>
          <a:lstStyle>
            <a:lvl1pPr>
              <a:defRPr sz="4041"/>
            </a:lvl1pPr>
            <a:lvl2pPr>
              <a:defRPr sz="3464"/>
            </a:lvl2pPr>
            <a:lvl3pPr>
              <a:defRPr sz="2887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335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112" y="2180432"/>
            <a:ext cx="3288264" cy="908699"/>
          </a:xfrm>
        </p:spPr>
        <p:txBody>
          <a:bodyPr anchor="b"/>
          <a:lstStyle>
            <a:lvl1pPr marL="0" indent="0">
              <a:buNone/>
              <a:defRPr sz="3464" b="1"/>
            </a:lvl1pPr>
            <a:lvl2pPr marL="659903" indent="0">
              <a:buNone/>
              <a:defRPr sz="2887" b="1"/>
            </a:lvl2pPr>
            <a:lvl3pPr marL="1319806" indent="0">
              <a:buNone/>
              <a:defRPr sz="2598" b="1"/>
            </a:lvl3pPr>
            <a:lvl4pPr marL="1979708" indent="0">
              <a:buNone/>
              <a:defRPr sz="2309" b="1"/>
            </a:lvl4pPr>
            <a:lvl5pPr marL="2639611" indent="0">
              <a:buNone/>
              <a:defRPr sz="2309" b="1"/>
            </a:lvl5pPr>
            <a:lvl6pPr marL="3299516" indent="0">
              <a:buNone/>
              <a:defRPr sz="2309" b="1"/>
            </a:lvl6pPr>
            <a:lvl7pPr marL="3959416" indent="0">
              <a:buNone/>
              <a:defRPr sz="2309" b="1"/>
            </a:lvl7pPr>
            <a:lvl8pPr marL="4619318" indent="0">
              <a:buNone/>
              <a:defRPr sz="2309" b="1"/>
            </a:lvl8pPr>
            <a:lvl9pPr marL="5279223" indent="0">
              <a:buNone/>
              <a:defRPr sz="230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112" y="3089131"/>
            <a:ext cx="3288264" cy="5612292"/>
          </a:xfrm>
        </p:spPr>
        <p:txBody>
          <a:bodyPr/>
          <a:lstStyle>
            <a:lvl1pPr>
              <a:defRPr sz="3464"/>
            </a:lvl1pPr>
            <a:lvl2pPr>
              <a:defRPr sz="2887"/>
            </a:lvl2pPr>
            <a:lvl3pPr>
              <a:defRPr sz="2598"/>
            </a:lvl3pPr>
            <a:lvl4pPr>
              <a:defRPr sz="2309"/>
            </a:lvl4pPr>
            <a:lvl5pPr>
              <a:defRPr sz="2309"/>
            </a:lvl5pPr>
            <a:lvl6pPr>
              <a:defRPr sz="2309"/>
            </a:lvl6pPr>
            <a:lvl7pPr>
              <a:defRPr sz="2309"/>
            </a:lvl7pPr>
            <a:lvl8pPr>
              <a:defRPr sz="2309"/>
            </a:lvl8pPr>
            <a:lvl9pPr>
              <a:defRPr sz="23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80546" y="2180432"/>
            <a:ext cx="3289555" cy="908699"/>
          </a:xfrm>
        </p:spPr>
        <p:txBody>
          <a:bodyPr anchor="b"/>
          <a:lstStyle>
            <a:lvl1pPr marL="0" indent="0">
              <a:buNone/>
              <a:defRPr sz="3464" b="1"/>
            </a:lvl1pPr>
            <a:lvl2pPr marL="659903" indent="0">
              <a:buNone/>
              <a:defRPr sz="2887" b="1"/>
            </a:lvl2pPr>
            <a:lvl3pPr marL="1319806" indent="0">
              <a:buNone/>
              <a:defRPr sz="2598" b="1"/>
            </a:lvl3pPr>
            <a:lvl4pPr marL="1979708" indent="0">
              <a:buNone/>
              <a:defRPr sz="2309" b="1"/>
            </a:lvl4pPr>
            <a:lvl5pPr marL="2639611" indent="0">
              <a:buNone/>
              <a:defRPr sz="2309" b="1"/>
            </a:lvl5pPr>
            <a:lvl6pPr marL="3299516" indent="0">
              <a:buNone/>
              <a:defRPr sz="2309" b="1"/>
            </a:lvl6pPr>
            <a:lvl7pPr marL="3959416" indent="0">
              <a:buNone/>
              <a:defRPr sz="2309" b="1"/>
            </a:lvl7pPr>
            <a:lvl8pPr marL="4619318" indent="0">
              <a:buNone/>
              <a:defRPr sz="2309" b="1"/>
            </a:lvl8pPr>
            <a:lvl9pPr marL="5279223" indent="0">
              <a:buNone/>
              <a:defRPr sz="230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80546" y="3089131"/>
            <a:ext cx="3289555" cy="5612292"/>
          </a:xfrm>
        </p:spPr>
        <p:txBody>
          <a:bodyPr/>
          <a:lstStyle>
            <a:lvl1pPr>
              <a:defRPr sz="3464"/>
            </a:lvl1pPr>
            <a:lvl2pPr>
              <a:defRPr sz="2887"/>
            </a:lvl2pPr>
            <a:lvl3pPr>
              <a:defRPr sz="2598"/>
            </a:lvl3pPr>
            <a:lvl4pPr>
              <a:defRPr sz="2309"/>
            </a:lvl4pPr>
            <a:lvl5pPr>
              <a:defRPr sz="2309"/>
            </a:lvl5pPr>
            <a:lvl6pPr>
              <a:defRPr sz="2309"/>
            </a:lvl6pPr>
            <a:lvl7pPr>
              <a:defRPr sz="2309"/>
            </a:lvl7pPr>
            <a:lvl8pPr>
              <a:defRPr sz="2309"/>
            </a:lvl8pPr>
            <a:lvl9pPr>
              <a:defRPr sz="23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597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111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017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121" y="387834"/>
            <a:ext cx="2448433" cy="1650541"/>
          </a:xfrm>
        </p:spPr>
        <p:txBody>
          <a:bodyPr anchor="b"/>
          <a:lstStyle>
            <a:lvl1pPr algn="l">
              <a:defRPr sz="288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9704" y="387838"/>
            <a:ext cx="4160397" cy="8313588"/>
          </a:xfrm>
        </p:spPr>
        <p:txBody>
          <a:bodyPr/>
          <a:lstStyle>
            <a:lvl1pPr>
              <a:defRPr sz="4619"/>
            </a:lvl1pPr>
            <a:lvl2pPr>
              <a:defRPr sz="4041"/>
            </a:lvl2pPr>
            <a:lvl3pPr>
              <a:defRPr sz="3464"/>
            </a:lvl3pPr>
            <a:lvl4pPr>
              <a:defRPr sz="2887"/>
            </a:lvl4pPr>
            <a:lvl5pPr>
              <a:defRPr sz="2887"/>
            </a:lvl5pPr>
            <a:lvl6pPr>
              <a:defRPr sz="2887"/>
            </a:lvl6pPr>
            <a:lvl7pPr>
              <a:defRPr sz="2887"/>
            </a:lvl7pPr>
            <a:lvl8pPr>
              <a:defRPr sz="2887"/>
            </a:lvl8pPr>
            <a:lvl9pPr>
              <a:defRPr sz="288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121" y="2038380"/>
            <a:ext cx="2448433" cy="6663047"/>
          </a:xfrm>
        </p:spPr>
        <p:txBody>
          <a:bodyPr/>
          <a:lstStyle>
            <a:lvl1pPr marL="0" indent="0">
              <a:buNone/>
              <a:defRPr sz="2021"/>
            </a:lvl1pPr>
            <a:lvl2pPr marL="659903" indent="0">
              <a:buNone/>
              <a:defRPr sz="1732"/>
            </a:lvl2pPr>
            <a:lvl3pPr marL="1319806" indent="0">
              <a:buNone/>
              <a:defRPr sz="1443"/>
            </a:lvl3pPr>
            <a:lvl4pPr marL="1979708" indent="0">
              <a:buNone/>
              <a:defRPr sz="1299"/>
            </a:lvl4pPr>
            <a:lvl5pPr marL="2639611" indent="0">
              <a:buNone/>
              <a:defRPr sz="1299"/>
            </a:lvl5pPr>
            <a:lvl6pPr marL="3299516" indent="0">
              <a:buNone/>
              <a:defRPr sz="1299"/>
            </a:lvl6pPr>
            <a:lvl7pPr marL="3959416" indent="0">
              <a:buNone/>
              <a:defRPr sz="1299"/>
            </a:lvl7pPr>
            <a:lvl8pPr marL="4619318" indent="0">
              <a:buNone/>
              <a:defRPr sz="1299"/>
            </a:lvl8pPr>
            <a:lvl9pPr marL="5279223" indent="0">
              <a:buNone/>
              <a:defRPr sz="12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911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8723" y="6818636"/>
            <a:ext cx="4465320" cy="804978"/>
          </a:xfrm>
        </p:spPr>
        <p:txBody>
          <a:bodyPr anchor="b"/>
          <a:lstStyle>
            <a:lvl1pPr algn="l">
              <a:defRPr sz="288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58723" y="870368"/>
            <a:ext cx="4465320" cy="5844540"/>
          </a:xfrm>
        </p:spPr>
        <p:txBody>
          <a:bodyPr/>
          <a:lstStyle>
            <a:lvl1pPr marL="0" indent="0">
              <a:buNone/>
              <a:defRPr sz="4619"/>
            </a:lvl1pPr>
            <a:lvl2pPr marL="659903" indent="0">
              <a:buNone/>
              <a:defRPr sz="4041"/>
            </a:lvl2pPr>
            <a:lvl3pPr marL="1319806" indent="0">
              <a:buNone/>
              <a:defRPr sz="3464"/>
            </a:lvl3pPr>
            <a:lvl4pPr marL="1979708" indent="0">
              <a:buNone/>
              <a:defRPr sz="2887"/>
            </a:lvl4pPr>
            <a:lvl5pPr marL="2639611" indent="0">
              <a:buNone/>
              <a:defRPr sz="2887"/>
            </a:lvl5pPr>
            <a:lvl6pPr marL="3299516" indent="0">
              <a:buNone/>
              <a:defRPr sz="2887"/>
            </a:lvl6pPr>
            <a:lvl7pPr marL="3959416" indent="0">
              <a:buNone/>
              <a:defRPr sz="2887"/>
            </a:lvl7pPr>
            <a:lvl8pPr marL="4619318" indent="0">
              <a:buNone/>
              <a:defRPr sz="2887"/>
            </a:lvl8pPr>
            <a:lvl9pPr marL="5279223" indent="0">
              <a:buNone/>
              <a:defRPr sz="288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58723" y="7623613"/>
            <a:ext cx="4465320" cy="1143202"/>
          </a:xfrm>
        </p:spPr>
        <p:txBody>
          <a:bodyPr/>
          <a:lstStyle>
            <a:lvl1pPr marL="0" indent="0">
              <a:buNone/>
              <a:defRPr sz="2021"/>
            </a:lvl1pPr>
            <a:lvl2pPr marL="659903" indent="0">
              <a:buNone/>
              <a:defRPr sz="1732"/>
            </a:lvl2pPr>
            <a:lvl3pPr marL="1319806" indent="0">
              <a:buNone/>
              <a:defRPr sz="1443"/>
            </a:lvl3pPr>
            <a:lvl4pPr marL="1979708" indent="0">
              <a:buNone/>
              <a:defRPr sz="1299"/>
            </a:lvl4pPr>
            <a:lvl5pPr marL="2639611" indent="0">
              <a:buNone/>
              <a:defRPr sz="1299"/>
            </a:lvl5pPr>
            <a:lvl6pPr marL="3299516" indent="0">
              <a:buNone/>
              <a:defRPr sz="1299"/>
            </a:lvl6pPr>
            <a:lvl7pPr marL="3959416" indent="0">
              <a:buNone/>
              <a:defRPr sz="1299"/>
            </a:lvl7pPr>
            <a:lvl8pPr marL="4619318" indent="0">
              <a:buNone/>
              <a:defRPr sz="1299"/>
            </a:lvl8pPr>
            <a:lvl9pPr marL="5279223" indent="0">
              <a:buNone/>
              <a:defRPr sz="12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585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2110" y="390088"/>
            <a:ext cx="6697980" cy="16234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110" y="2272883"/>
            <a:ext cx="6697980" cy="64285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2110" y="9028376"/>
            <a:ext cx="1736513" cy="518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AE006E-699A-4BA2-836F-5A58D9682716}" type="datetimeFigureOut">
              <a:rPr lang="en-US" smtClean="0"/>
              <a:t>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42753" y="9028376"/>
            <a:ext cx="2356697" cy="518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3577" y="9028376"/>
            <a:ext cx="1736513" cy="518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622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19806" rtl="0" eaLnBrk="1" latinLnBrk="0" hangingPunct="1">
        <a:spcBef>
          <a:spcPct val="0"/>
        </a:spcBef>
        <a:buNone/>
        <a:defRPr sz="63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4926" indent="-494926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4619" kern="1200">
          <a:solidFill>
            <a:schemeClr val="tx1"/>
          </a:solidFill>
          <a:latin typeface="+mn-lt"/>
          <a:ea typeface="+mn-ea"/>
          <a:cs typeface="+mn-cs"/>
        </a:defRPr>
      </a:lvl1pPr>
      <a:lvl2pPr marL="1072340" indent="-412441" algn="l" defTabSz="1319806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1" kern="1200">
          <a:solidFill>
            <a:schemeClr val="tx1"/>
          </a:solidFill>
          <a:latin typeface="+mn-lt"/>
          <a:ea typeface="+mn-ea"/>
          <a:cs typeface="+mn-cs"/>
        </a:defRPr>
      </a:lvl2pPr>
      <a:lvl3pPr marL="1649757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4" kern="1200">
          <a:solidFill>
            <a:schemeClr val="tx1"/>
          </a:solidFill>
          <a:latin typeface="+mn-lt"/>
          <a:ea typeface="+mn-ea"/>
          <a:cs typeface="+mn-cs"/>
        </a:defRPr>
      </a:lvl3pPr>
      <a:lvl4pPr marL="2309660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7" kern="1200">
          <a:solidFill>
            <a:schemeClr val="tx1"/>
          </a:solidFill>
          <a:latin typeface="+mn-lt"/>
          <a:ea typeface="+mn-ea"/>
          <a:cs typeface="+mn-cs"/>
        </a:defRPr>
      </a:lvl4pPr>
      <a:lvl5pPr marL="2969564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»"/>
        <a:defRPr sz="2887" kern="1200">
          <a:solidFill>
            <a:schemeClr val="tx1"/>
          </a:solidFill>
          <a:latin typeface="+mn-lt"/>
          <a:ea typeface="+mn-ea"/>
          <a:cs typeface="+mn-cs"/>
        </a:defRPr>
      </a:lvl5pPr>
      <a:lvl6pPr marL="3629466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6pPr>
      <a:lvl7pPr marL="4289367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7pPr>
      <a:lvl8pPr marL="4949272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8pPr>
      <a:lvl9pPr marL="5609176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1pPr>
      <a:lvl2pPr marL="659903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2pPr>
      <a:lvl3pPr marL="1319806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3pPr>
      <a:lvl4pPr marL="1979708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4pPr>
      <a:lvl5pPr marL="2639611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5pPr>
      <a:lvl6pPr marL="3299516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6pPr>
      <a:lvl7pPr marL="3959416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7pPr>
      <a:lvl8pPr marL="4619318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8pPr>
      <a:lvl9pPr marL="5279223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gif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e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706E1CA-626E-467D-593C-0057BB6A2FEA}"/>
              </a:ext>
            </a:extLst>
          </p:cNvPr>
          <p:cNvSpPr txBox="1"/>
          <p:nvPr/>
        </p:nvSpPr>
        <p:spPr>
          <a:xfrm>
            <a:off x="12700" y="-31750"/>
            <a:ext cx="3111500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Supplementary Fig. 1.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1B92327-31CB-614A-D505-DE770E18F202}"/>
              </a:ext>
            </a:extLst>
          </p:cNvPr>
          <p:cNvSpPr txBox="1"/>
          <p:nvPr/>
        </p:nvSpPr>
        <p:spPr>
          <a:xfrm>
            <a:off x="370306" y="484940"/>
            <a:ext cx="496147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A.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26710EE-A656-3547-974F-F1654F7242CD}"/>
              </a:ext>
            </a:extLst>
          </p:cNvPr>
          <p:cNvSpPr txBox="1"/>
          <p:nvPr/>
        </p:nvSpPr>
        <p:spPr>
          <a:xfrm>
            <a:off x="3059853" y="488950"/>
            <a:ext cx="496147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B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482CDF10-2FE6-493B-D78B-BDA2C5FCB7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7700" y="895350"/>
            <a:ext cx="1927860" cy="33147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E3E22C3-029E-611F-7B63-DEAD49EBF0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38800" y="908050"/>
            <a:ext cx="1714500" cy="32613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2FAF0CE-C08E-EBB2-BDAB-55A593FAAE0C}"/>
              </a:ext>
            </a:extLst>
          </p:cNvPr>
          <p:cNvSpPr txBox="1"/>
          <p:nvPr/>
        </p:nvSpPr>
        <p:spPr>
          <a:xfrm>
            <a:off x="5129953" y="481779"/>
            <a:ext cx="496147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C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59890E0D-C052-1E06-0F26-26B51D92F12C}"/>
              </a:ext>
            </a:extLst>
          </p:cNvPr>
          <p:cNvGrpSpPr>
            <a:grpSpLocks noChangeAspect="1"/>
          </p:cNvGrpSpPr>
          <p:nvPr/>
        </p:nvGrpSpPr>
        <p:grpSpPr>
          <a:xfrm>
            <a:off x="420794" y="872310"/>
            <a:ext cx="2548880" cy="3301158"/>
            <a:chOff x="3608533" y="1650837"/>
            <a:chExt cx="2254480" cy="2919869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180096E-D499-2615-0C32-87EB27E51F2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08533" y="2048189"/>
              <a:ext cx="2061633" cy="2522517"/>
            </a:xfrm>
            <a:prstGeom prst="rect">
              <a:avLst/>
            </a:prstGeom>
            <a:ln w="28575">
              <a:noFill/>
            </a:ln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C46985B-0BF3-1030-D740-40FF64746E21}"/>
                </a:ext>
              </a:extLst>
            </p:cNvPr>
            <p:cNvSpPr txBox="1"/>
            <p:nvPr/>
          </p:nvSpPr>
          <p:spPr>
            <a:xfrm>
              <a:off x="3935153" y="1650837"/>
              <a:ext cx="192786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</a:rPr>
                <a:t>MET</a:t>
              </a:r>
              <a:r>
                <a:rPr lang="en-US" b="1" dirty="0"/>
                <a:t>/</a:t>
              </a:r>
              <a:r>
                <a:rPr lang="en-US" b="1" dirty="0">
                  <a:solidFill>
                    <a:srgbClr val="00B050"/>
                  </a:solidFill>
                </a:rPr>
                <a:t>CEP7: </a:t>
              </a:r>
              <a:r>
                <a:rPr lang="en-US" b="1" dirty="0"/>
                <a:t>11.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1580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id="{5969EA7F-FB68-DB87-0E67-2222D6BC63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33" t="1514" r="1562" b="-285"/>
          <a:stretch/>
        </p:blipFill>
        <p:spPr>
          <a:xfrm>
            <a:off x="55123" y="1746250"/>
            <a:ext cx="7323577" cy="573680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61BB8FC9-F99B-24EA-6DE9-AD1249A38568}"/>
              </a:ext>
            </a:extLst>
          </p:cNvPr>
          <p:cNvSpPr txBox="1"/>
          <p:nvPr/>
        </p:nvSpPr>
        <p:spPr>
          <a:xfrm>
            <a:off x="62895" y="7298"/>
            <a:ext cx="3111500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Supplementary Fig. 2.</a:t>
            </a:r>
          </a:p>
        </p:txBody>
      </p:sp>
    </p:spTree>
    <p:extLst>
      <p:ext uri="{BB962C8B-B14F-4D97-AF65-F5344CB8AC3E}">
        <p14:creationId xmlns:p14="http://schemas.microsoft.com/office/powerpoint/2010/main" val="921400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2E81227-6814-AE56-7F47-B9D26741467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17" t="2549" r="5822" b="2733"/>
          <a:stretch/>
        </p:blipFill>
        <p:spPr>
          <a:xfrm>
            <a:off x="901700" y="1248766"/>
            <a:ext cx="2593253" cy="285968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D00C317-F43B-1E65-51F5-B322BBD30A1D}"/>
              </a:ext>
            </a:extLst>
          </p:cNvPr>
          <p:cNvSpPr txBox="1"/>
          <p:nvPr/>
        </p:nvSpPr>
        <p:spPr>
          <a:xfrm>
            <a:off x="0" y="29566"/>
            <a:ext cx="3111500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Supplementary Fig. 3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F0713F-A5FC-50BD-ECF6-819A10153C7A}"/>
              </a:ext>
            </a:extLst>
          </p:cNvPr>
          <p:cNvSpPr txBox="1"/>
          <p:nvPr/>
        </p:nvSpPr>
        <p:spPr>
          <a:xfrm>
            <a:off x="368300" y="791566"/>
            <a:ext cx="496147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5D4417-6F40-393D-6F6D-8C6DB19392D7}"/>
              </a:ext>
            </a:extLst>
          </p:cNvPr>
          <p:cNvSpPr txBox="1"/>
          <p:nvPr/>
        </p:nvSpPr>
        <p:spPr>
          <a:xfrm>
            <a:off x="4025900" y="791566"/>
            <a:ext cx="496147" cy="426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70" b="1" dirty="0"/>
              <a:t>B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1D3BF6D-0006-0B0B-85D1-D2B3775702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36" t="3053" r="8321" b="2604"/>
          <a:stretch/>
        </p:blipFill>
        <p:spPr>
          <a:xfrm>
            <a:off x="4031265" y="1477366"/>
            <a:ext cx="2356835" cy="2291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0488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FB14EE7-EEF6-61F7-41BC-5E90AAE62A50}"/>
              </a:ext>
            </a:extLst>
          </p:cNvPr>
          <p:cNvSpPr txBox="1"/>
          <p:nvPr/>
        </p:nvSpPr>
        <p:spPr>
          <a:xfrm>
            <a:off x="139700" y="7505"/>
            <a:ext cx="31877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ry Fig. 4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0745951-7BFA-ACAA-D3B9-F109297E6D86}"/>
              </a:ext>
            </a:extLst>
          </p:cNvPr>
          <p:cNvSpPr txBox="1"/>
          <p:nvPr/>
        </p:nvSpPr>
        <p:spPr>
          <a:xfrm>
            <a:off x="292100" y="831850"/>
            <a:ext cx="457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.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42524B6-CD05-7E8E-53B3-CF6EDDB555D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80" t="5245" r="12041" b="4079"/>
          <a:stretch/>
        </p:blipFill>
        <p:spPr>
          <a:xfrm>
            <a:off x="444500" y="4902718"/>
            <a:ext cx="2819400" cy="263473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6DBA533-46D5-F4DE-11B3-F9F694AA03DD}"/>
              </a:ext>
            </a:extLst>
          </p:cNvPr>
          <p:cNvSpPr txBox="1"/>
          <p:nvPr/>
        </p:nvSpPr>
        <p:spPr>
          <a:xfrm>
            <a:off x="228600" y="4184650"/>
            <a:ext cx="468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CC9087F6-E3EE-D2AC-5475-46666060E1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66" r="1707" b="3166"/>
          <a:stretch/>
        </p:blipFill>
        <p:spPr>
          <a:xfrm>
            <a:off x="172682" y="1365250"/>
            <a:ext cx="7206018" cy="2192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050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9192685B-096A-390B-990A-6D2575FA6F5E}"/>
              </a:ext>
            </a:extLst>
          </p:cNvPr>
          <p:cNvGrpSpPr/>
          <p:nvPr/>
        </p:nvGrpSpPr>
        <p:grpSpPr>
          <a:xfrm>
            <a:off x="-16042" y="-61556"/>
            <a:ext cx="7421078" cy="9764690"/>
            <a:chOff x="-16042" y="-61556"/>
            <a:chExt cx="7421078" cy="9764690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836C5DC-7746-C954-BC1F-3B9F0DA30868}"/>
                </a:ext>
              </a:extLst>
            </p:cNvPr>
            <p:cNvSpPr txBox="1"/>
            <p:nvPr/>
          </p:nvSpPr>
          <p:spPr>
            <a:xfrm>
              <a:off x="-16042" y="-61556"/>
              <a:ext cx="396917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Supplementary Fig. 5.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64871AB-6521-A550-17B9-FEE41DAD3B8D}"/>
                </a:ext>
              </a:extLst>
            </p:cNvPr>
            <p:cNvSpPr txBox="1"/>
            <p:nvPr/>
          </p:nvSpPr>
          <p:spPr>
            <a:xfrm>
              <a:off x="14423" y="216868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A.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E106EEB-BEC0-DFC6-0302-FA2E623AEC2C}"/>
                </a:ext>
              </a:extLst>
            </p:cNvPr>
            <p:cNvSpPr txBox="1"/>
            <p:nvPr/>
          </p:nvSpPr>
          <p:spPr>
            <a:xfrm>
              <a:off x="2878147" y="216064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B.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933CC69-5A26-CFFF-CDF2-7629C88162CC}"/>
                </a:ext>
              </a:extLst>
            </p:cNvPr>
            <p:cNvSpPr txBox="1"/>
            <p:nvPr/>
          </p:nvSpPr>
          <p:spPr>
            <a:xfrm>
              <a:off x="0" y="2860193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C.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00AC389-8A93-6C81-C33A-970A6A288B38}"/>
                </a:ext>
              </a:extLst>
            </p:cNvPr>
            <p:cNvSpPr txBox="1"/>
            <p:nvPr/>
          </p:nvSpPr>
          <p:spPr>
            <a:xfrm>
              <a:off x="3730201" y="2861582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D.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2E43E6A-BC7F-1E66-77AD-0D7CCFDBED82}"/>
                </a:ext>
              </a:extLst>
            </p:cNvPr>
            <p:cNvSpPr txBox="1"/>
            <p:nvPr/>
          </p:nvSpPr>
          <p:spPr>
            <a:xfrm>
              <a:off x="19384" y="5175355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E.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7E78BC5-387C-1374-456C-397866B099A1}"/>
                </a:ext>
              </a:extLst>
            </p:cNvPr>
            <p:cNvSpPr txBox="1"/>
            <p:nvPr/>
          </p:nvSpPr>
          <p:spPr>
            <a:xfrm>
              <a:off x="3767454" y="5134306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F.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E811E4C-18B9-AF7B-4E24-A0D0D5FB3A2B}"/>
                </a:ext>
              </a:extLst>
            </p:cNvPr>
            <p:cNvSpPr txBox="1"/>
            <p:nvPr/>
          </p:nvSpPr>
          <p:spPr>
            <a:xfrm>
              <a:off x="-11689" y="7569993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G.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97D5A89-7757-9ED2-8EE0-4D250796B5BB}"/>
                </a:ext>
              </a:extLst>
            </p:cNvPr>
            <p:cNvSpPr txBox="1"/>
            <p:nvPr/>
          </p:nvSpPr>
          <p:spPr>
            <a:xfrm>
              <a:off x="3690095" y="7569993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H.</a:t>
              </a: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FFA80ACD-6E47-C912-D959-62C82A221811}"/>
                </a:ext>
              </a:extLst>
            </p:cNvPr>
            <p:cNvGrpSpPr/>
            <p:nvPr/>
          </p:nvGrpSpPr>
          <p:grpSpPr>
            <a:xfrm>
              <a:off x="464810" y="2853154"/>
              <a:ext cx="2595636" cy="2298032"/>
              <a:chOff x="150906" y="2853154"/>
              <a:chExt cx="2595636" cy="2298032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29DD6D63-398D-9D2D-9E3E-6E02392446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198" t="2492" r="9335" b="2829"/>
              <a:stretch/>
            </p:blipFill>
            <p:spPr>
              <a:xfrm>
                <a:off x="150906" y="2980115"/>
                <a:ext cx="2595636" cy="2171071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4400196-BCAC-9BA2-4B49-9C0650D949FE}"/>
                  </a:ext>
                </a:extLst>
              </p:cNvPr>
              <p:cNvSpPr txBox="1"/>
              <p:nvPr/>
            </p:nvSpPr>
            <p:spPr>
              <a:xfrm>
                <a:off x="1258738" y="2853154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1437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D49AB123-0B24-44D0-BBEC-64F7DAD6605F}"/>
                </a:ext>
              </a:extLst>
            </p:cNvPr>
            <p:cNvGrpSpPr/>
            <p:nvPr/>
          </p:nvGrpSpPr>
          <p:grpSpPr>
            <a:xfrm>
              <a:off x="4263601" y="2875602"/>
              <a:ext cx="2547391" cy="2156973"/>
              <a:chOff x="3993109" y="2875602"/>
              <a:chExt cx="2547391" cy="2156973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0E6A30FA-1FCE-8E20-3A3D-C9977710E4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095" t="5333" r="10167" b="4013"/>
              <a:stretch/>
            </p:blipFill>
            <p:spPr>
              <a:xfrm>
                <a:off x="3993109" y="3131680"/>
                <a:ext cx="2547391" cy="1900895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CC265AF-7197-6A73-CFD5-2B69A8F31CE8}"/>
                  </a:ext>
                </a:extLst>
              </p:cNvPr>
              <p:cNvSpPr txBox="1"/>
              <p:nvPr/>
            </p:nvSpPr>
            <p:spPr>
              <a:xfrm>
                <a:off x="5020922" y="2875602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1437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04B2C1A9-EB0C-406C-9E17-296446427152}"/>
                </a:ext>
              </a:extLst>
            </p:cNvPr>
            <p:cNvGrpSpPr/>
            <p:nvPr/>
          </p:nvGrpSpPr>
          <p:grpSpPr>
            <a:xfrm>
              <a:off x="505632" y="5113729"/>
              <a:ext cx="2595636" cy="2307415"/>
              <a:chOff x="287264" y="5113729"/>
              <a:chExt cx="2595636" cy="2307415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54C9136E-B2EE-713C-206F-528275B3E9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116" t="3188" r="9416" b="2715"/>
              <a:stretch/>
            </p:blipFill>
            <p:spPr>
              <a:xfrm>
                <a:off x="287264" y="5211476"/>
                <a:ext cx="2595636" cy="2209668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3E43CA10-C496-3957-DE7D-2FE5CADA6483}"/>
                  </a:ext>
                </a:extLst>
              </p:cNvPr>
              <p:cNvSpPr txBox="1"/>
              <p:nvPr/>
            </p:nvSpPr>
            <p:spPr>
              <a:xfrm>
                <a:off x="1466570" y="5113729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596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58024AC3-3CAA-AE70-9F80-D889D4427085}"/>
                </a:ext>
              </a:extLst>
            </p:cNvPr>
            <p:cNvGrpSpPr/>
            <p:nvPr/>
          </p:nvGrpSpPr>
          <p:grpSpPr>
            <a:xfrm>
              <a:off x="4296392" y="5099050"/>
              <a:ext cx="2518444" cy="2224609"/>
              <a:chOff x="4025900" y="5099050"/>
              <a:chExt cx="2518444" cy="222460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571617C-7D69-5378-001F-634F214B4A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696" t="3750" r="10551" b="3235"/>
              <a:stretch/>
            </p:blipFill>
            <p:spPr>
              <a:xfrm>
                <a:off x="4025900" y="5287676"/>
                <a:ext cx="2518444" cy="2035983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ACFDAD4-CFAE-4293-2D1E-2E7069303D0D}"/>
                  </a:ext>
                </a:extLst>
              </p:cNvPr>
              <p:cNvSpPr txBox="1"/>
              <p:nvPr/>
            </p:nvSpPr>
            <p:spPr>
              <a:xfrm>
                <a:off x="5129982" y="5099050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596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0B6DC18-3449-5500-FA84-0BB5842C8EE1}"/>
                </a:ext>
              </a:extLst>
            </p:cNvPr>
            <p:cNvGrpSpPr/>
            <p:nvPr/>
          </p:nvGrpSpPr>
          <p:grpSpPr>
            <a:xfrm>
              <a:off x="539168" y="7577554"/>
              <a:ext cx="2489496" cy="2125580"/>
              <a:chOff x="657058" y="7577554"/>
              <a:chExt cx="2489496" cy="212558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6D86FB7-83E1-07B1-6A6C-3A5DDE32D6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154" t="3797" r="11185" b="4103"/>
              <a:stretch/>
            </p:blipFill>
            <p:spPr>
              <a:xfrm>
                <a:off x="657058" y="7715398"/>
                <a:ext cx="2489496" cy="1987736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2F78356-5DC0-07EC-252C-29848BFBDEBE}"/>
                  </a:ext>
                </a:extLst>
              </p:cNvPr>
              <p:cNvSpPr txBox="1"/>
              <p:nvPr/>
            </p:nvSpPr>
            <p:spPr>
              <a:xfrm>
                <a:off x="1647290" y="7577554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1993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4B17F00-0356-0926-27BE-A8E46FD045E6}"/>
                </a:ext>
              </a:extLst>
            </p:cNvPr>
            <p:cNvGrpSpPr/>
            <p:nvPr/>
          </p:nvGrpSpPr>
          <p:grpSpPr>
            <a:xfrm>
              <a:off x="4321541" y="7587970"/>
              <a:ext cx="2441249" cy="2044795"/>
              <a:chOff x="4051049" y="7628914"/>
              <a:chExt cx="2441249" cy="2044795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5DF73724-2E56-FF83-751A-F90FBC4935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3838" t="7557" r="13037" b="3631"/>
              <a:stretch/>
            </p:blipFill>
            <p:spPr>
              <a:xfrm>
                <a:off x="4051049" y="7811411"/>
                <a:ext cx="2441249" cy="1862298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03104D2-55F4-ADA5-9E39-AC4196EBFDF5}"/>
                  </a:ext>
                </a:extLst>
              </p:cNvPr>
              <p:cNvSpPr txBox="1"/>
              <p:nvPr/>
            </p:nvSpPr>
            <p:spPr>
              <a:xfrm>
                <a:off x="5090594" y="7628914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1993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5A7F8E08-0902-36DF-CC2A-98D5D838096B}"/>
                </a:ext>
              </a:extLst>
            </p:cNvPr>
            <p:cNvGrpSpPr/>
            <p:nvPr/>
          </p:nvGrpSpPr>
          <p:grpSpPr>
            <a:xfrm>
              <a:off x="2902954" y="234282"/>
              <a:ext cx="4502082" cy="2581451"/>
              <a:chOff x="2866858" y="222250"/>
              <a:chExt cx="4502082" cy="2581451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50E22F7A-0AEA-69B1-4EBE-B57F9FBCB1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639"/>
              <a:stretch/>
            </p:blipFill>
            <p:spPr>
              <a:xfrm>
                <a:off x="2866858" y="527050"/>
                <a:ext cx="4502082" cy="2276651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5BC2E56-2E3E-36E3-0FA3-67C96EA49A89}"/>
                  </a:ext>
                </a:extLst>
              </p:cNvPr>
              <p:cNvSpPr txBox="1"/>
              <p:nvPr/>
            </p:nvSpPr>
            <p:spPr>
              <a:xfrm>
                <a:off x="5182834" y="222250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1993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48D14474-21BE-E3B9-27B2-6A46B84D7BB6}"/>
                </a:ext>
              </a:extLst>
            </p:cNvPr>
            <p:cNvGrpSpPr/>
            <p:nvPr/>
          </p:nvGrpSpPr>
          <p:grpSpPr>
            <a:xfrm>
              <a:off x="79903" y="337137"/>
              <a:ext cx="2662221" cy="2382995"/>
              <a:chOff x="79903" y="295473"/>
              <a:chExt cx="2662221" cy="2382995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BA586AAC-EA6F-0435-4C2A-DF34082B00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3544" t="7488" r="2700" b="3491"/>
              <a:stretch/>
            </p:blipFill>
            <p:spPr>
              <a:xfrm>
                <a:off x="79903" y="548692"/>
                <a:ext cx="2662221" cy="2129776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92D989F-07E3-DF99-0F1C-AE47DC3163C0}"/>
                  </a:ext>
                </a:extLst>
              </p:cNvPr>
              <p:cNvSpPr txBox="1"/>
              <p:nvPr/>
            </p:nvSpPr>
            <p:spPr>
              <a:xfrm>
                <a:off x="1067314" y="295473"/>
                <a:ext cx="728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H1993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134052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47F1819-444C-8B7F-1403-160F673742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07" t="2214" r="1193" b="1"/>
          <a:stretch/>
        </p:blipFill>
        <p:spPr>
          <a:xfrm>
            <a:off x="174956" y="298450"/>
            <a:ext cx="3526856" cy="27646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6DD0B48-B345-CF1F-AC35-22438CCC0C8B}"/>
              </a:ext>
            </a:extLst>
          </p:cNvPr>
          <p:cNvSpPr txBox="1"/>
          <p:nvPr/>
        </p:nvSpPr>
        <p:spPr>
          <a:xfrm>
            <a:off x="215900" y="-6350"/>
            <a:ext cx="496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I.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6CBAF858-50D9-8F7C-6DF5-67EBF5C98E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7985" y="247745"/>
            <a:ext cx="3310715" cy="325110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963910ED-36A7-503E-D426-41AE7A8316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5900" y="3721350"/>
            <a:ext cx="3306132" cy="3269448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AE750BBF-E519-06D9-A8B7-E559F7A7A8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01719" y="3718269"/>
            <a:ext cx="3338229" cy="3237349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59665A96-21CF-3CB0-568D-F73C9511EFD8}"/>
              </a:ext>
            </a:extLst>
          </p:cNvPr>
          <p:cNvSpPr txBox="1"/>
          <p:nvPr/>
        </p:nvSpPr>
        <p:spPr>
          <a:xfrm>
            <a:off x="4025900" y="-6057"/>
            <a:ext cx="496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J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5941A31-F9CC-2694-9DF5-562FECB4D269}"/>
              </a:ext>
            </a:extLst>
          </p:cNvPr>
          <p:cNvSpPr txBox="1"/>
          <p:nvPr/>
        </p:nvSpPr>
        <p:spPr>
          <a:xfrm>
            <a:off x="215900" y="3349238"/>
            <a:ext cx="496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K.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514ABBE-AC9F-7F63-CD41-1A43A7AD490F}"/>
              </a:ext>
            </a:extLst>
          </p:cNvPr>
          <p:cNvSpPr txBox="1"/>
          <p:nvPr/>
        </p:nvSpPr>
        <p:spPr>
          <a:xfrm>
            <a:off x="4025900" y="3346450"/>
            <a:ext cx="496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L.</a:t>
            </a:r>
          </a:p>
        </p:txBody>
      </p:sp>
    </p:spTree>
    <p:extLst>
      <p:ext uri="{BB962C8B-B14F-4D97-AF65-F5344CB8AC3E}">
        <p14:creationId xmlns:p14="http://schemas.microsoft.com/office/powerpoint/2010/main" val="15328161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151524F-6A93-4591-E74C-61195CFB589E}"/>
              </a:ext>
            </a:extLst>
          </p:cNvPr>
          <p:cNvGrpSpPr/>
          <p:nvPr/>
        </p:nvGrpSpPr>
        <p:grpSpPr>
          <a:xfrm>
            <a:off x="-16042" y="-56032"/>
            <a:ext cx="7623342" cy="9779209"/>
            <a:chOff x="-16042" y="-56032"/>
            <a:chExt cx="7623342" cy="9779209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3A89AD1-9494-8A53-6332-6DA335F33ECF}"/>
                </a:ext>
              </a:extLst>
            </p:cNvPr>
            <p:cNvSpPr txBox="1"/>
            <p:nvPr/>
          </p:nvSpPr>
          <p:spPr>
            <a:xfrm>
              <a:off x="-16042" y="-56032"/>
              <a:ext cx="3969173" cy="426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Supplementary</a:t>
              </a:r>
              <a:r>
                <a:rPr lang="en-US" sz="2170" b="1" dirty="0"/>
                <a:t> Fig. 6.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6602624-7F01-EC5F-7DCF-E4FD97D849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4621" y="450850"/>
              <a:ext cx="2481287" cy="238374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9A5EDE8-83BF-C1F5-FE1F-C91A13ECAC86}"/>
                </a:ext>
              </a:extLst>
            </p:cNvPr>
            <p:cNvSpPr txBox="1"/>
            <p:nvPr/>
          </p:nvSpPr>
          <p:spPr>
            <a:xfrm>
              <a:off x="65772" y="292762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A.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08EE6BE-26ED-084B-CFDA-83892522EE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91" t="8072" r="5215" b="3451"/>
            <a:stretch/>
          </p:blipFill>
          <p:spPr>
            <a:xfrm>
              <a:off x="4016612" y="3333939"/>
              <a:ext cx="3425588" cy="238835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7BB9DB2-7785-93BD-48B9-5493F27373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03" t="4069" r="4437" b="3289"/>
            <a:stretch/>
          </p:blipFill>
          <p:spPr>
            <a:xfrm>
              <a:off x="0" y="3207698"/>
              <a:ext cx="3521122" cy="255213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56EF732-3FB9-4B75-8022-CF8EBC1765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563" t="4772" r="7030" b="3670"/>
            <a:stretch/>
          </p:blipFill>
          <p:spPr>
            <a:xfrm>
              <a:off x="3955388" y="552006"/>
              <a:ext cx="3425588" cy="256577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1589004-5581-8664-6C28-D36C9B6610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098" t="3303" r="5246" b="4387"/>
            <a:stretch/>
          </p:blipFill>
          <p:spPr>
            <a:xfrm>
              <a:off x="139700" y="6136282"/>
              <a:ext cx="3439235" cy="278414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890E6BB-FCDC-AFAE-806A-AF9938194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49700" y="6065577"/>
              <a:ext cx="3657600" cy="36576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27EE938-1CB7-E066-BFC9-1C59CA6B9DDF}"/>
                </a:ext>
              </a:extLst>
            </p:cNvPr>
            <p:cNvSpPr txBox="1"/>
            <p:nvPr/>
          </p:nvSpPr>
          <p:spPr>
            <a:xfrm>
              <a:off x="3721100" y="298450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B.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2B105F6-F840-377B-D976-C2AD8CB4C5F1}"/>
                </a:ext>
              </a:extLst>
            </p:cNvPr>
            <p:cNvSpPr txBox="1"/>
            <p:nvPr/>
          </p:nvSpPr>
          <p:spPr>
            <a:xfrm>
              <a:off x="63500" y="2899708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C.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68F6C60-C84D-779C-52D5-DFD694A8E9B5}"/>
                </a:ext>
              </a:extLst>
            </p:cNvPr>
            <p:cNvSpPr txBox="1"/>
            <p:nvPr/>
          </p:nvSpPr>
          <p:spPr>
            <a:xfrm>
              <a:off x="3718828" y="2905396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D.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1775FC4-4D76-D18F-C620-DC49A6F16F19}"/>
                </a:ext>
              </a:extLst>
            </p:cNvPr>
            <p:cNvSpPr txBox="1"/>
            <p:nvPr/>
          </p:nvSpPr>
          <p:spPr>
            <a:xfrm>
              <a:off x="65772" y="5800996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E.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B13C716-2734-A971-9A49-4B9A3B633355}"/>
                </a:ext>
              </a:extLst>
            </p:cNvPr>
            <p:cNvSpPr txBox="1"/>
            <p:nvPr/>
          </p:nvSpPr>
          <p:spPr>
            <a:xfrm>
              <a:off x="3721100" y="5806684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F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518745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9D7FB63E-C2EE-D58F-8058-9CC23195215E}"/>
              </a:ext>
            </a:extLst>
          </p:cNvPr>
          <p:cNvGrpSpPr/>
          <p:nvPr/>
        </p:nvGrpSpPr>
        <p:grpSpPr>
          <a:xfrm>
            <a:off x="19191" y="-25460"/>
            <a:ext cx="7321744" cy="9620310"/>
            <a:chOff x="19191" y="-25460"/>
            <a:chExt cx="7321744" cy="962031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56CA07C-310B-7CB3-A9A5-D9A9ED7A54FF}"/>
                </a:ext>
              </a:extLst>
            </p:cNvPr>
            <p:cNvSpPr txBox="1"/>
            <p:nvPr/>
          </p:nvSpPr>
          <p:spPr>
            <a:xfrm>
              <a:off x="19191" y="-25460"/>
              <a:ext cx="396917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Supplementary Fig. 7.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98F8A0C-194E-FF4D-7289-8864350071D4}"/>
                </a:ext>
              </a:extLst>
            </p:cNvPr>
            <p:cNvSpPr txBox="1"/>
            <p:nvPr/>
          </p:nvSpPr>
          <p:spPr>
            <a:xfrm>
              <a:off x="4873504" y="358730"/>
              <a:ext cx="1026909" cy="32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19" b="1" dirty="0"/>
                <a:t>H1437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0EABD4C-5A9D-7A62-CF2E-6C0640B39C2F}"/>
                </a:ext>
              </a:extLst>
            </p:cNvPr>
            <p:cNvSpPr txBox="1"/>
            <p:nvPr/>
          </p:nvSpPr>
          <p:spPr>
            <a:xfrm>
              <a:off x="1170375" y="5150226"/>
              <a:ext cx="1026909" cy="32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19" b="1" dirty="0"/>
                <a:t>H1648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A17C6E1-9E7E-0426-0C8C-C1A35E1C7DC3}"/>
                </a:ext>
              </a:extLst>
            </p:cNvPr>
            <p:cNvSpPr txBox="1"/>
            <p:nvPr/>
          </p:nvSpPr>
          <p:spPr>
            <a:xfrm>
              <a:off x="1054182" y="388298"/>
              <a:ext cx="1026909" cy="32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19" b="1" dirty="0"/>
                <a:t>H143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9C3B8BA-B97C-4483-7DDA-C04CF0B7D5BD}"/>
                </a:ext>
              </a:extLst>
            </p:cNvPr>
            <p:cNvSpPr txBox="1"/>
            <p:nvPr/>
          </p:nvSpPr>
          <p:spPr>
            <a:xfrm>
              <a:off x="5056391" y="2756186"/>
              <a:ext cx="1026909" cy="32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19" b="1" dirty="0"/>
                <a:t>H596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E9FD58F-64C2-0A03-90AD-E94581A8B3C0}"/>
                </a:ext>
              </a:extLst>
            </p:cNvPr>
            <p:cNvSpPr txBox="1"/>
            <p:nvPr/>
          </p:nvSpPr>
          <p:spPr>
            <a:xfrm>
              <a:off x="5187629" y="5161602"/>
              <a:ext cx="1026909" cy="32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19" b="1" dirty="0"/>
                <a:t>H1648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CC663BE-9D93-F87F-7818-C877356A5B1C}"/>
                </a:ext>
              </a:extLst>
            </p:cNvPr>
            <p:cNvSpPr txBox="1"/>
            <p:nvPr/>
          </p:nvSpPr>
          <p:spPr>
            <a:xfrm>
              <a:off x="69277" y="275622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A.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EA2DED9-D02B-BD07-2DDB-1844946C07FC}"/>
                </a:ext>
              </a:extLst>
            </p:cNvPr>
            <p:cNvSpPr txBox="1"/>
            <p:nvPr/>
          </p:nvSpPr>
          <p:spPr>
            <a:xfrm>
              <a:off x="3873068" y="271274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B.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5C4C9A3-0A8D-5EF8-010D-CF3030AE0D95}"/>
                </a:ext>
              </a:extLst>
            </p:cNvPr>
            <p:cNvSpPr txBox="1"/>
            <p:nvPr/>
          </p:nvSpPr>
          <p:spPr>
            <a:xfrm>
              <a:off x="69277" y="2556710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C.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A61F1F1-2458-F05A-D6AC-BFB7017688BA}"/>
                </a:ext>
              </a:extLst>
            </p:cNvPr>
            <p:cNvSpPr txBox="1"/>
            <p:nvPr/>
          </p:nvSpPr>
          <p:spPr>
            <a:xfrm>
              <a:off x="57245" y="5060118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E.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60CD5E2-7907-5398-3CE4-410188CBFD00}"/>
                </a:ext>
              </a:extLst>
            </p:cNvPr>
            <p:cNvSpPr txBox="1"/>
            <p:nvPr/>
          </p:nvSpPr>
          <p:spPr>
            <a:xfrm>
              <a:off x="3861036" y="5055770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F.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60CB73A7-14FE-042F-5656-C468FC0E6F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49319" y="612403"/>
              <a:ext cx="3453181" cy="2160365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386F0B05-F7BB-5932-D2EE-B54F705C16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426" y="657010"/>
              <a:ext cx="3334106" cy="2012937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9B759E7-C5D6-9DAE-715D-F0293F1F50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40229" y="3000113"/>
              <a:ext cx="3453181" cy="2160365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3758AC8-16FA-94B8-4DA8-AE833AE6A83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6687" y="2982617"/>
              <a:ext cx="3458850" cy="2012937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AB7334A-7D84-E21C-4840-A55B123B485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87754" y="5406513"/>
              <a:ext cx="3453181" cy="208665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8015BC2-1828-B74E-A8EC-FAED8514FFE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2799" y="5489203"/>
              <a:ext cx="3396478" cy="1984587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E6DE9711-8ED1-7832-D742-5D0C043C538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5565" y="7880619"/>
              <a:ext cx="3503135" cy="1714231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B6C7636-0898-60A7-0EFB-7BCB47A579CA}"/>
                </a:ext>
              </a:extLst>
            </p:cNvPr>
            <p:cNvSpPr txBox="1"/>
            <p:nvPr/>
          </p:nvSpPr>
          <p:spPr>
            <a:xfrm>
              <a:off x="63500" y="7585974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G.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1B118E8-7CDF-B7BF-4C99-2C803483AE33}"/>
                </a:ext>
              </a:extLst>
            </p:cNvPr>
            <p:cNvSpPr txBox="1"/>
            <p:nvPr/>
          </p:nvSpPr>
          <p:spPr>
            <a:xfrm>
              <a:off x="1206500" y="2750498"/>
              <a:ext cx="1026909" cy="32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19" b="1" dirty="0"/>
                <a:t>H596</a:t>
              </a:r>
            </a:p>
          </p:txBody>
        </p:sp>
        <p:sp>
          <p:nvSpPr>
            <p:cNvPr id="78" name="Rectangle: Rounded Corners 77">
              <a:extLst>
                <a:ext uri="{FF2B5EF4-FFF2-40B4-BE49-F238E27FC236}">
                  <a16:creationId xmlns:a16="http://schemas.microsoft.com/office/drawing/2014/main" id="{C7DEFC74-5C8B-324C-067B-389707FE8CF2}"/>
                </a:ext>
              </a:extLst>
            </p:cNvPr>
            <p:cNvSpPr/>
            <p:nvPr/>
          </p:nvSpPr>
          <p:spPr>
            <a:xfrm>
              <a:off x="1816100" y="8909050"/>
              <a:ext cx="304800" cy="228600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: Rounded Corners 78">
              <a:extLst>
                <a:ext uri="{FF2B5EF4-FFF2-40B4-BE49-F238E27FC236}">
                  <a16:creationId xmlns:a16="http://schemas.microsoft.com/office/drawing/2014/main" id="{0B717167-A04A-9635-8E24-2CE62D70A68E}"/>
                </a:ext>
              </a:extLst>
            </p:cNvPr>
            <p:cNvSpPr/>
            <p:nvPr/>
          </p:nvSpPr>
          <p:spPr>
            <a:xfrm>
              <a:off x="2912780" y="8891122"/>
              <a:ext cx="304800" cy="228600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tangle: Rounded Corners 79">
              <a:extLst>
                <a:ext uri="{FF2B5EF4-FFF2-40B4-BE49-F238E27FC236}">
                  <a16:creationId xmlns:a16="http://schemas.microsoft.com/office/drawing/2014/main" id="{2525AAE4-7B4D-17F2-D2C9-AA4869F4BE97}"/>
                </a:ext>
              </a:extLst>
            </p:cNvPr>
            <p:cNvSpPr/>
            <p:nvPr/>
          </p:nvSpPr>
          <p:spPr>
            <a:xfrm>
              <a:off x="953996" y="8891122"/>
              <a:ext cx="304800" cy="228600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AC4EA1E-77D3-AF0F-9802-6AF75082BFD9}"/>
                </a:ext>
              </a:extLst>
            </p:cNvPr>
            <p:cNvSpPr txBox="1"/>
            <p:nvPr/>
          </p:nvSpPr>
          <p:spPr>
            <a:xfrm>
              <a:off x="3834553" y="2553465"/>
              <a:ext cx="4961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D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31753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15</TotalTime>
  <Words>118</Words>
  <Application>Microsoft Office PowerPoint</Application>
  <PresentationFormat>Custom</PresentationFormat>
  <Paragraphs>5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s, Timothy</dc:creator>
  <cp:lastModifiedBy>Kumar, Vinod</cp:lastModifiedBy>
  <cp:revision>241</cp:revision>
  <cp:lastPrinted>2015-12-15T14:05:04Z</cp:lastPrinted>
  <dcterms:created xsi:type="dcterms:W3CDTF">2015-09-22T14:13:33Z</dcterms:created>
  <dcterms:modified xsi:type="dcterms:W3CDTF">2024-02-05T20:1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2-11-02T20:29:07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15f993b8-f611-491b-9c49-2a10b823d971</vt:lpwstr>
  </property>
  <property fmtid="{D5CDD505-2E9C-101B-9397-08002B2CF9AE}" pid="8" name="MSIP_Label_5e4b1be8-281e-475d-98b0-21c3457e5a46_ContentBits">
    <vt:lpwstr>0</vt:lpwstr>
  </property>
</Properties>
</file>